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2" d="100"/>
          <a:sy n="52" d="100"/>
        </p:scale>
        <p:origin x="223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23E439-5FAB-4E05-AADF-ADF4C6A45CFF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7FC5A4-808C-42FC-8351-F50A42EF9F3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02461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1" dirty="0"/>
              <a:t>LDLR expression does not consistently correlate with MRBV sensitivity across heterogeneous ascites cells or its </a:t>
            </a:r>
            <a:r>
              <a:rPr lang="en-CA" sz="1200" b="1" dirty="0" err="1"/>
              <a:t>subclonal</a:t>
            </a:r>
            <a:r>
              <a:rPr lang="en-CA" sz="1200" b="1" dirty="0"/>
              <a:t> populations.</a:t>
            </a:r>
            <a:r>
              <a:rPr lang="en-CA" sz="1200" dirty="0"/>
              <a:t>   Cells were seeded at 500,000 cells/ well of a 6 well plate.  Lysates were generated 24hrs after seeding.  Parallel wells were used for infection to verify MRBV sensitivity.  </a:t>
            </a:r>
            <a:r>
              <a:rPr lang="en-CA" sz="1200" b="1" dirty="0"/>
              <a:t> </a:t>
            </a:r>
          </a:p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F9313F-5089-4DFC-B405-72C405BECBDE}" type="slidenum">
              <a:rPr lang="en-CA" smtClean="0"/>
              <a:pPr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882208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06595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43523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0355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42481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41166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90272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29337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71720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36206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99204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2643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0C4EDB-0DD4-4232-B20F-A69C3AF24088}" type="datetimeFigureOut">
              <a:rPr lang="en-CA" smtClean="0"/>
              <a:t>2017-01-0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6CB500-8411-4D97-A445-92D967F4CA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86526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76672" y="2279481"/>
            <a:ext cx="681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LDLR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76672" y="3296251"/>
            <a:ext cx="880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ctin</a:t>
            </a:r>
          </a:p>
        </p:txBody>
      </p:sp>
      <p:sp>
        <p:nvSpPr>
          <p:cNvPr id="3" name="TextBox 2"/>
          <p:cNvSpPr txBox="1"/>
          <p:nvPr/>
        </p:nvSpPr>
        <p:spPr>
          <a:xfrm rot="16200000">
            <a:off x="776566" y="1419556"/>
            <a:ext cx="1296085" cy="33855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CA" sz="1600" dirty="0"/>
              <a:t>iOvCa105 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1221000" y="1419556"/>
            <a:ext cx="1296085" cy="33855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CA" sz="1600" dirty="0"/>
              <a:t>iOvCa131 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1626446" y="1419556"/>
            <a:ext cx="1296085" cy="33855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CA" sz="1600" dirty="0"/>
              <a:t>iOvCa142 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2044592" y="1419556"/>
            <a:ext cx="1296085" cy="33855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CA" sz="1600" dirty="0"/>
              <a:t>iOvCa147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106488" y="3674020"/>
            <a:ext cx="430887" cy="8859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600" dirty="0">
                <a:solidFill>
                  <a:srgbClr val="00B050"/>
                </a:solidFill>
              </a:rPr>
              <a:t>Sensitive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655621" y="3674020"/>
            <a:ext cx="430887" cy="89798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600" dirty="0">
                <a:solidFill>
                  <a:srgbClr val="FF0000"/>
                </a:solidFill>
              </a:rPr>
              <a:t>Resistant</a:t>
            </a:r>
          </a:p>
        </p:txBody>
      </p:sp>
      <p:pic>
        <p:nvPicPr>
          <p:cNvPr id="1030" name="Picture 10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9707" y="3309976"/>
            <a:ext cx="2613920" cy="367118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031" name="Picture 1030"/>
          <p:cNvPicPr>
            <a:picLocks noChangeAspect="1"/>
          </p:cNvPicPr>
          <p:nvPr/>
        </p:nvPicPr>
        <p:blipFill>
          <a:blip r:embed="rId4">
            <a:lum/>
          </a:blip>
          <a:stretch>
            <a:fillRect/>
          </a:stretch>
        </p:blipFill>
        <p:spPr>
          <a:xfrm>
            <a:off x="1117980" y="3309976"/>
            <a:ext cx="1924238" cy="364045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032" name="Picture 103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27514" y="2222853"/>
            <a:ext cx="1914704" cy="990600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033" name="Picture 1032"/>
          <p:cNvPicPr>
            <a:picLocks noChangeAspect="1"/>
          </p:cNvPicPr>
          <p:nvPr/>
        </p:nvPicPr>
        <p:blipFill>
          <a:blip r:embed="rId6">
            <a:lum bright="-1000"/>
          </a:blip>
          <a:stretch>
            <a:fillRect/>
          </a:stretch>
        </p:blipFill>
        <p:spPr>
          <a:xfrm>
            <a:off x="3336648" y="2228096"/>
            <a:ext cx="2616979" cy="985357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sp>
        <p:nvSpPr>
          <p:cNvPr id="31" name="TextBox 30"/>
          <p:cNvSpPr txBox="1"/>
          <p:nvPr/>
        </p:nvSpPr>
        <p:spPr>
          <a:xfrm>
            <a:off x="-27384" y="26204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Figure S4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128363" y="3674020"/>
            <a:ext cx="430887" cy="89798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600" dirty="0">
                <a:solidFill>
                  <a:srgbClr val="FF0000"/>
                </a:solidFill>
              </a:rPr>
              <a:t>Resistant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352499" y="3674020"/>
            <a:ext cx="430887" cy="89798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600" dirty="0">
                <a:solidFill>
                  <a:srgbClr val="FF0000"/>
                </a:solidFill>
              </a:rPr>
              <a:t>Resistant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152699" y="3674020"/>
            <a:ext cx="430887" cy="89798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600" dirty="0">
                <a:solidFill>
                  <a:srgbClr val="FF0000"/>
                </a:solidFill>
              </a:rPr>
              <a:t>Resistant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5512739" y="3674020"/>
            <a:ext cx="430887" cy="89798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600" dirty="0">
                <a:solidFill>
                  <a:srgbClr val="FF0000"/>
                </a:solidFill>
              </a:rPr>
              <a:t>Resistant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560411" y="3674020"/>
            <a:ext cx="430887" cy="8859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600" dirty="0">
                <a:solidFill>
                  <a:srgbClr val="00B050"/>
                </a:solidFill>
              </a:rPr>
              <a:t>Sensitive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712539" y="3674020"/>
            <a:ext cx="430887" cy="8859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600" dirty="0">
                <a:solidFill>
                  <a:srgbClr val="00B050"/>
                </a:solidFill>
              </a:rPr>
              <a:t>Sensitive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072579" y="3674020"/>
            <a:ext cx="430887" cy="8859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600" dirty="0">
                <a:solidFill>
                  <a:srgbClr val="00B050"/>
                </a:solidFill>
              </a:rPr>
              <a:t>Sensitive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432619" y="3674020"/>
            <a:ext cx="430887" cy="8859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600" dirty="0">
                <a:solidFill>
                  <a:srgbClr val="00B050"/>
                </a:solidFill>
              </a:rPr>
              <a:t>Sensitive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792659" y="3674020"/>
            <a:ext cx="430887" cy="8859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1600" dirty="0">
                <a:solidFill>
                  <a:srgbClr val="00B050"/>
                </a:solidFill>
              </a:rPr>
              <a:t>Sensitive</a:t>
            </a:r>
          </a:p>
        </p:txBody>
      </p:sp>
      <p:sp>
        <p:nvSpPr>
          <p:cNvPr id="41" name="TextBox 40"/>
          <p:cNvSpPr txBox="1"/>
          <p:nvPr/>
        </p:nvSpPr>
        <p:spPr>
          <a:xfrm rot="16200000">
            <a:off x="2905363" y="1419556"/>
            <a:ext cx="1296085" cy="33855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CA" sz="1600" dirty="0"/>
              <a:t>iOvCa147-B3 </a:t>
            </a:r>
          </a:p>
        </p:txBody>
      </p:sp>
      <p:sp>
        <p:nvSpPr>
          <p:cNvPr id="42" name="TextBox 41"/>
          <p:cNvSpPr txBox="1"/>
          <p:nvPr/>
        </p:nvSpPr>
        <p:spPr>
          <a:xfrm rot="16200000">
            <a:off x="3267826" y="1419556"/>
            <a:ext cx="1296085" cy="33855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CA" sz="1600" dirty="0"/>
              <a:t>iOvCa147-C8 </a:t>
            </a:r>
          </a:p>
        </p:txBody>
      </p:sp>
      <p:sp>
        <p:nvSpPr>
          <p:cNvPr id="43" name="TextBox 42"/>
          <p:cNvSpPr txBox="1"/>
          <p:nvPr/>
        </p:nvSpPr>
        <p:spPr>
          <a:xfrm rot="16200000">
            <a:off x="3630289" y="1419556"/>
            <a:ext cx="1296085" cy="33855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CA" sz="1600" dirty="0"/>
              <a:t>iOvCa147-E2 </a:t>
            </a:r>
          </a:p>
        </p:txBody>
      </p:sp>
      <p:sp>
        <p:nvSpPr>
          <p:cNvPr id="44" name="TextBox 43"/>
          <p:cNvSpPr txBox="1"/>
          <p:nvPr/>
        </p:nvSpPr>
        <p:spPr>
          <a:xfrm rot="16200000">
            <a:off x="3992752" y="1419556"/>
            <a:ext cx="1296085" cy="33855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CA" sz="1600" dirty="0"/>
              <a:t>iOvCa147-F5 </a:t>
            </a:r>
          </a:p>
        </p:txBody>
      </p:sp>
      <p:sp>
        <p:nvSpPr>
          <p:cNvPr id="45" name="TextBox 44"/>
          <p:cNvSpPr txBox="1"/>
          <p:nvPr/>
        </p:nvSpPr>
        <p:spPr>
          <a:xfrm rot="16200000">
            <a:off x="4355215" y="1419556"/>
            <a:ext cx="1296085" cy="33855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CA" sz="1600" dirty="0"/>
              <a:t>iOvCa147-F8 </a:t>
            </a:r>
          </a:p>
        </p:txBody>
      </p:sp>
      <p:sp>
        <p:nvSpPr>
          <p:cNvPr id="46" name="TextBox 45"/>
          <p:cNvSpPr txBox="1"/>
          <p:nvPr/>
        </p:nvSpPr>
        <p:spPr>
          <a:xfrm rot="16200000">
            <a:off x="4717678" y="1419556"/>
            <a:ext cx="1296085" cy="33855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CA" sz="1600" dirty="0"/>
              <a:t>iOvCa147-G4 </a:t>
            </a:r>
          </a:p>
        </p:txBody>
      </p:sp>
      <p:sp>
        <p:nvSpPr>
          <p:cNvPr id="47" name="TextBox 46"/>
          <p:cNvSpPr txBox="1"/>
          <p:nvPr/>
        </p:nvSpPr>
        <p:spPr>
          <a:xfrm rot="16200000">
            <a:off x="5080140" y="1419556"/>
            <a:ext cx="1296085" cy="33855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CA" sz="1600" dirty="0"/>
              <a:t>iOvCa147-G7 </a:t>
            </a:r>
          </a:p>
        </p:txBody>
      </p:sp>
    </p:spTree>
    <p:extLst>
      <p:ext uri="{BB962C8B-B14F-4D97-AF65-F5344CB8AC3E}">
        <p14:creationId xmlns:p14="http://schemas.microsoft.com/office/powerpoint/2010/main" val="2190559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7</Words>
  <Application>Microsoft Office PowerPoint</Application>
  <PresentationFormat>Letter Paper (8.5x11 in)</PresentationFormat>
  <Paragraphs>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shepherd</dc:creator>
  <cp:lastModifiedBy>tshepherd</cp:lastModifiedBy>
  <cp:revision>2</cp:revision>
  <dcterms:created xsi:type="dcterms:W3CDTF">2016-11-14T20:18:35Z</dcterms:created>
  <dcterms:modified xsi:type="dcterms:W3CDTF">2017-01-03T19:08:34Z</dcterms:modified>
</cp:coreProperties>
</file>